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6" r:id="rId2"/>
    <p:sldId id="257" r:id="rId3"/>
  </p:sldIdLst>
  <p:sldSz cx="35999738" cy="5039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49" autoAdjust="0"/>
    <p:restoredTop sz="94517" autoAdjust="0"/>
  </p:normalViewPr>
  <p:slideViewPr>
    <p:cSldViewPr snapToGrid="0">
      <p:cViewPr>
        <p:scale>
          <a:sx n="30" d="100"/>
          <a:sy n="30" d="100"/>
        </p:scale>
        <p:origin x="56" y="-38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8248330"/>
            <a:ext cx="30599777" cy="17546649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8" y="26471644"/>
            <a:ext cx="26999804" cy="12168319"/>
          </a:xfrm>
        </p:spPr>
        <p:txBody>
          <a:bodyPr/>
          <a:lstStyle>
            <a:lvl1pPr marL="0" indent="0" algn="ctr">
              <a:buNone/>
              <a:defRPr sz="9449"/>
            </a:lvl1pPr>
            <a:lvl2pPr marL="1800016" indent="0" algn="ctr">
              <a:buNone/>
              <a:defRPr sz="7874"/>
            </a:lvl2pPr>
            <a:lvl3pPr marL="3600032" indent="0" algn="ctr">
              <a:buNone/>
              <a:defRPr sz="7087"/>
            </a:lvl3pPr>
            <a:lvl4pPr marL="5400047" indent="0" algn="ctr">
              <a:buNone/>
              <a:defRPr sz="6299"/>
            </a:lvl4pPr>
            <a:lvl5pPr marL="7200063" indent="0" algn="ctr">
              <a:buNone/>
              <a:defRPr sz="6299"/>
            </a:lvl5pPr>
            <a:lvl6pPr marL="9000079" indent="0" algn="ctr">
              <a:buNone/>
              <a:defRPr sz="6299"/>
            </a:lvl6pPr>
            <a:lvl7pPr marL="10800093" indent="0" algn="ctr">
              <a:buNone/>
              <a:defRPr sz="6299"/>
            </a:lvl7pPr>
            <a:lvl8pPr marL="12600110" indent="0" algn="ctr">
              <a:buNone/>
              <a:defRPr sz="6299"/>
            </a:lvl8pPr>
            <a:lvl9pPr marL="14400124" indent="0" algn="ctr">
              <a:buNone/>
              <a:defRPr sz="629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229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28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2683331"/>
            <a:ext cx="7762444" cy="427116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2683331"/>
            <a:ext cx="22837334" cy="427116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689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812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12565002"/>
            <a:ext cx="31049774" cy="20964977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33728317"/>
            <a:ext cx="31049774" cy="11024985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80001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600032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400047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200063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900007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800093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600110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400124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347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3" y="13416654"/>
            <a:ext cx="15299889" cy="31978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13416654"/>
            <a:ext cx="15299889" cy="31978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088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683344"/>
            <a:ext cx="31049774" cy="97416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12354992"/>
            <a:ext cx="15229574" cy="6054990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800016" indent="0">
              <a:buNone/>
              <a:defRPr sz="7874" b="1"/>
            </a:lvl2pPr>
            <a:lvl3pPr marL="3600032" indent="0">
              <a:buNone/>
              <a:defRPr sz="7087" b="1"/>
            </a:lvl3pPr>
            <a:lvl4pPr marL="5400047" indent="0">
              <a:buNone/>
              <a:defRPr sz="6299" b="1"/>
            </a:lvl4pPr>
            <a:lvl5pPr marL="7200063" indent="0">
              <a:buNone/>
              <a:defRPr sz="6299" b="1"/>
            </a:lvl5pPr>
            <a:lvl6pPr marL="9000079" indent="0">
              <a:buNone/>
              <a:defRPr sz="6299" b="1"/>
            </a:lvl6pPr>
            <a:lvl7pPr marL="10800093" indent="0">
              <a:buNone/>
              <a:defRPr sz="6299" b="1"/>
            </a:lvl7pPr>
            <a:lvl8pPr marL="12600110" indent="0">
              <a:buNone/>
              <a:defRPr sz="6299" b="1"/>
            </a:lvl8pPr>
            <a:lvl9pPr marL="14400124" indent="0">
              <a:buNone/>
              <a:defRPr sz="62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8409982"/>
            <a:ext cx="15229574" cy="270783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12354992"/>
            <a:ext cx="15304578" cy="6054990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800016" indent="0">
              <a:buNone/>
              <a:defRPr sz="7874" b="1"/>
            </a:lvl2pPr>
            <a:lvl3pPr marL="3600032" indent="0">
              <a:buNone/>
              <a:defRPr sz="7087" b="1"/>
            </a:lvl3pPr>
            <a:lvl4pPr marL="5400047" indent="0">
              <a:buNone/>
              <a:defRPr sz="6299" b="1"/>
            </a:lvl4pPr>
            <a:lvl5pPr marL="7200063" indent="0">
              <a:buNone/>
              <a:defRPr sz="6299" b="1"/>
            </a:lvl5pPr>
            <a:lvl6pPr marL="9000079" indent="0">
              <a:buNone/>
              <a:defRPr sz="6299" b="1"/>
            </a:lvl6pPr>
            <a:lvl7pPr marL="10800093" indent="0">
              <a:buNone/>
              <a:defRPr sz="6299" b="1"/>
            </a:lvl7pPr>
            <a:lvl8pPr marL="12600110" indent="0">
              <a:buNone/>
              <a:defRPr sz="6299" b="1"/>
            </a:lvl8pPr>
            <a:lvl9pPr marL="14400124" indent="0">
              <a:buNone/>
              <a:defRPr sz="62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8409982"/>
            <a:ext cx="15304578" cy="270783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066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355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881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3359997"/>
            <a:ext cx="11610853" cy="11759988"/>
          </a:xfrm>
        </p:spPr>
        <p:txBody>
          <a:bodyPr anchor="b"/>
          <a:lstStyle>
            <a:lvl1pPr>
              <a:defRPr sz="125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9" y="7256673"/>
            <a:ext cx="18224867" cy="35816631"/>
          </a:xfrm>
        </p:spPr>
        <p:txBody>
          <a:bodyPr/>
          <a:lstStyle>
            <a:lvl1pPr>
              <a:defRPr sz="12599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5119985"/>
            <a:ext cx="11610853" cy="28011643"/>
          </a:xfrm>
        </p:spPr>
        <p:txBody>
          <a:bodyPr/>
          <a:lstStyle>
            <a:lvl1pPr marL="0" indent="0">
              <a:buNone/>
              <a:defRPr sz="6299"/>
            </a:lvl1pPr>
            <a:lvl2pPr marL="1800016" indent="0">
              <a:buNone/>
              <a:defRPr sz="5512"/>
            </a:lvl2pPr>
            <a:lvl3pPr marL="3600032" indent="0">
              <a:buNone/>
              <a:defRPr sz="4724"/>
            </a:lvl3pPr>
            <a:lvl4pPr marL="5400047" indent="0">
              <a:buNone/>
              <a:defRPr sz="3937"/>
            </a:lvl4pPr>
            <a:lvl5pPr marL="7200063" indent="0">
              <a:buNone/>
              <a:defRPr sz="3937"/>
            </a:lvl5pPr>
            <a:lvl6pPr marL="9000079" indent="0">
              <a:buNone/>
              <a:defRPr sz="3937"/>
            </a:lvl6pPr>
            <a:lvl7pPr marL="10800093" indent="0">
              <a:buNone/>
              <a:defRPr sz="3937"/>
            </a:lvl7pPr>
            <a:lvl8pPr marL="12600110" indent="0">
              <a:buNone/>
              <a:defRPr sz="3937"/>
            </a:lvl8pPr>
            <a:lvl9pPr marL="14400124" indent="0">
              <a:buNone/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522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3359997"/>
            <a:ext cx="11610853" cy="11759988"/>
          </a:xfrm>
        </p:spPr>
        <p:txBody>
          <a:bodyPr anchor="b"/>
          <a:lstStyle>
            <a:lvl1pPr>
              <a:defRPr sz="125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9" y="7256673"/>
            <a:ext cx="18224867" cy="35816631"/>
          </a:xfrm>
        </p:spPr>
        <p:txBody>
          <a:bodyPr anchor="t"/>
          <a:lstStyle>
            <a:lvl1pPr marL="0" indent="0">
              <a:buNone/>
              <a:defRPr sz="12599"/>
            </a:lvl1pPr>
            <a:lvl2pPr marL="1800016" indent="0">
              <a:buNone/>
              <a:defRPr sz="11024"/>
            </a:lvl2pPr>
            <a:lvl3pPr marL="3600032" indent="0">
              <a:buNone/>
              <a:defRPr sz="9449"/>
            </a:lvl3pPr>
            <a:lvl4pPr marL="5400047" indent="0">
              <a:buNone/>
              <a:defRPr sz="7874"/>
            </a:lvl4pPr>
            <a:lvl5pPr marL="7200063" indent="0">
              <a:buNone/>
              <a:defRPr sz="7874"/>
            </a:lvl5pPr>
            <a:lvl6pPr marL="9000079" indent="0">
              <a:buNone/>
              <a:defRPr sz="7874"/>
            </a:lvl6pPr>
            <a:lvl7pPr marL="10800093" indent="0">
              <a:buNone/>
              <a:defRPr sz="7874"/>
            </a:lvl7pPr>
            <a:lvl8pPr marL="12600110" indent="0">
              <a:buNone/>
              <a:defRPr sz="7874"/>
            </a:lvl8pPr>
            <a:lvl9pPr marL="14400124" indent="0">
              <a:buNone/>
              <a:defRPr sz="787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5119985"/>
            <a:ext cx="11610853" cy="28011643"/>
          </a:xfrm>
        </p:spPr>
        <p:txBody>
          <a:bodyPr/>
          <a:lstStyle>
            <a:lvl1pPr marL="0" indent="0">
              <a:buNone/>
              <a:defRPr sz="6299"/>
            </a:lvl1pPr>
            <a:lvl2pPr marL="1800016" indent="0">
              <a:buNone/>
              <a:defRPr sz="5512"/>
            </a:lvl2pPr>
            <a:lvl3pPr marL="3600032" indent="0">
              <a:buNone/>
              <a:defRPr sz="4724"/>
            </a:lvl3pPr>
            <a:lvl4pPr marL="5400047" indent="0">
              <a:buNone/>
              <a:defRPr sz="3937"/>
            </a:lvl4pPr>
            <a:lvl5pPr marL="7200063" indent="0">
              <a:buNone/>
              <a:defRPr sz="3937"/>
            </a:lvl5pPr>
            <a:lvl6pPr marL="9000079" indent="0">
              <a:buNone/>
              <a:defRPr sz="3937"/>
            </a:lvl6pPr>
            <a:lvl7pPr marL="10800093" indent="0">
              <a:buNone/>
              <a:defRPr sz="3937"/>
            </a:lvl7pPr>
            <a:lvl8pPr marL="12600110" indent="0">
              <a:buNone/>
              <a:defRPr sz="3937"/>
            </a:lvl8pPr>
            <a:lvl9pPr marL="14400124" indent="0">
              <a:buNone/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887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2683344"/>
            <a:ext cx="31049774" cy="97416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13416654"/>
            <a:ext cx="31049774" cy="319783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3" y="46713300"/>
            <a:ext cx="8099941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9176-AB36-4C60-AAE0-FCB838C82116}" type="datetimeFigureOut">
              <a:rPr lang="en-US" smtClean="0"/>
              <a:t>1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4" y="46713300"/>
            <a:ext cx="12149912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6" y="46713300"/>
            <a:ext cx="8099941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A42FF-4393-4F10-9738-09BB4C4B0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705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3600032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0008" indent="-900008" algn="l" defTabSz="3600032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700024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500039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300055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100071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900087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700102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500118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300132" indent="-900008" algn="l" defTabSz="3600032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800016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600032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400047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200063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000079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800093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600110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400124" algn="l" defTabSz="3600032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37DDD7E6-192A-B0C0-AD3B-42AAF87929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2950" y="4242815"/>
            <a:ext cx="9667472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DDE89FF-98AD-1006-8253-DCB2EA0C35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1195" y="10285537"/>
            <a:ext cx="9667472" cy="579587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227F47F-B196-2817-3A00-9EA13EF9D0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1227" y="16236185"/>
            <a:ext cx="9667472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697202B-D0AD-B1BE-EDF0-E09CD7F9FE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51227" y="22222692"/>
            <a:ext cx="9667472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EA39F91-83FA-5C3D-B3AD-694D117167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51225" y="28229547"/>
            <a:ext cx="9667472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BDE8F1D-865C-2C0D-583C-BD20CFA45F0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51219" y="40202559"/>
            <a:ext cx="9667481" cy="579587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5043282-4607-193D-3F35-89022C0060DA}"/>
              </a:ext>
            </a:extLst>
          </p:cNvPr>
          <p:cNvSpPr txBox="1"/>
          <p:nvPr/>
        </p:nvSpPr>
        <p:spPr>
          <a:xfrm>
            <a:off x="2459434" y="3098264"/>
            <a:ext cx="2947787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0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                            All causes death                                                               CVD death                                                                     Non-CVD death  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C5CA01F9-5023-F753-42A0-D0DD61C13CC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51217" y="34216042"/>
            <a:ext cx="9667481" cy="579587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034" name="Picture 1033">
            <a:extLst>
              <a:ext uri="{FF2B5EF4-FFF2-40B4-BE49-F238E27FC236}">
                <a16:creationId xmlns:a16="http://schemas.microsoft.com/office/drawing/2014/main" id="{C48ECBCF-92B7-770D-75B1-DA9D599709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917792" y="4242816"/>
            <a:ext cx="9667472" cy="5795865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036" name="Picture 1035">
            <a:extLst>
              <a:ext uri="{FF2B5EF4-FFF2-40B4-BE49-F238E27FC236}">
                <a16:creationId xmlns:a16="http://schemas.microsoft.com/office/drawing/2014/main" id="{CF4718EA-F2D9-D617-0844-1347A33D714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392634" y="4242815"/>
            <a:ext cx="9559413" cy="573108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6C92778-4B7B-1ADD-1832-CED7D304C52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917791" y="10285534"/>
            <a:ext cx="9667474" cy="5795867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FEC684C-9B77-C6FD-3E26-E3932082BF1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3392634" y="10317927"/>
            <a:ext cx="9559413" cy="573108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13DECBC-C823-8628-5EA6-95F14C96306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2917790" y="16236185"/>
            <a:ext cx="9667465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F136CF5-4BF9-C88B-1BC5-9078445A7BC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3384348" y="16236186"/>
            <a:ext cx="9559411" cy="5731079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A2DF6CE-8DEA-2976-1697-E3DAE42B540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917783" y="22222692"/>
            <a:ext cx="9667472" cy="5795867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D7EA724-0987-6D6E-6266-EBA58C84086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3392634" y="22222692"/>
            <a:ext cx="9559413" cy="573108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CCB8C01-7437-1DAA-0D60-E60EC533385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2917783" y="28209205"/>
            <a:ext cx="9667472" cy="5795865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A386C59-ADAD-DC42-1794-1ACC1254B61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3392634" y="28229546"/>
            <a:ext cx="9559415" cy="5731083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8CBACC4-359F-9472-2CF6-E02166E8493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917783" y="34195718"/>
            <a:ext cx="9667465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FDE99AB-EFE4-AF18-4D4D-E24415F3268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3338606" y="34195716"/>
            <a:ext cx="9667465" cy="5795861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B1A6414-D839-3A6B-F1CF-920EDBBB438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2917769" y="40182225"/>
            <a:ext cx="9667479" cy="579587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A5B0385-7163-5C75-8884-52F0A3056639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3338607" y="40182225"/>
            <a:ext cx="9610076" cy="5761455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251AD7F-AE24-576F-718E-C3BAC4CACA53}"/>
              </a:ext>
            </a:extLst>
          </p:cNvPr>
          <p:cNvSpPr txBox="1"/>
          <p:nvPr/>
        </p:nvSpPr>
        <p:spPr>
          <a:xfrm>
            <a:off x="2615610" y="46995909"/>
            <a:ext cx="30328148" cy="240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1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 1. </a:t>
            </a:r>
            <a:r>
              <a:rPr lang="en-US" sz="4401" dirty="0">
                <a:solidFill>
                  <a:srgbClr val="3E3D4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plan–Meier failure functions (All causes Death) or cumulative incidence function (CVD and non-CVD) for each health metric over follow-up time (evaluated at reference values for categorical age (&lt;65 years), sex (Male) and education (Primary Education)).</a:t>
            </a:r>
            <a:endParaRPr lang="en-US" sz="4401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US" sz="1801" dirty="0"/>
          </a:p>
        </p:txBody>
      </p:sp>
    </p:spTree>
    <p:extLst>
      <p:ext uri="{BB962C8B-B14F-4D97-AF65-F5344CB8AC3E}">
        <p14:creationId xmlns:p14="http://schemas.microsoft.com/office/powerpoint/2010/main" val="1197779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AB28D5D-9A7B-8343-D7E7-001EE5ECE7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11293" y="14467952"/>
            <a:ext cx="12257825" cy="7348839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5D9B6C1-4291-94E6-7A3C-09ABC7941ABC}"/>
              </a:ext>
            </a:extLst>
          </p:cNvPr>
          <p:cNvSpPr txBox="1"/>
          <p:nvPr/>
        </p:nvSpPr>
        <p:spPr>
          <a:xfrm>
            <a:off x="7144707" y="30866622"/>
            <a:ext cx="2480109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</a:t>
            </a:r>
            <a:r>
              <a:rPr lang="en-US" sz="3600" b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ntary </a:t>
            </a:r>
            <a:r>
              <a:rPr lang="en-US" sz="36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 2. </a:t>
            </a:r>
            <a:r>
              <a:rPr lang="en-US" sz="3600" dirty="0">
                <a:solidFill>
                  <a:srgbClr val="3E3D4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plan–Meier failure functions (All causes Death) or cumulative incidence function (CVD and non-CVD)  depending on the number of health metrics over follow-up time (evaluated at reference values for categorical age (&lt;65 years), sex (Male) and education (Primary Education)).</a:t>
            </a:r>
            <a:endParaRPr lang="en-US" sz="36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865152A-0DB8-6CD9-B473-9D3EF2CF10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11293" y="22563381"/>
            <a:ext cx="12257824" cy="7348839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C79A959-A627-D780-5FF0-8C35FF8FEE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11292" y="6180362"/>
            <a:ext cx="12257823" cy="7348838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946295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42</TotalTime>
  <Words>115</Words>
  <Application>Microsoft Office PowerPoint</Application>
  <PresentationFormat>Custom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a ponzano</dc:creator>
  <cp:lastModifiedBy>Weimin Ye</cp:lastModifiedBy>
  <cp:revision>28</cp:revision>
  <dcterms:created xsi:type="dcterms:W3CDTF">2023-10-04T09:37:55Z</dcterms:created>
  <dcterms:modified xsi:type="dcterms:W3CDTF">2023-11-10T17:18:31Z</dcterms:modified>
</cp:coreProperties>
</file>